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70" r:id="rId2"/>
    <p:sldId id="267" r:id="rId3"/>
    <p:sldId id="262" r:id="rId4"/>
    <p:sldId id="26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514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image" Target="../media/image2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image" Target="../media/image5.emf"/></Relationships>
</file>

<file path=ppt/drawings/_rels/vmlDrawing4.v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image" Target="../media/image7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649DC53-A993-4637-872F-8A04B856469F}" type="datetimeFigureOut">
              <a:rPr lang="en-CA" smtClean="0"/>
              <a:t>2020-12-09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A36AA0B-3A19-45A4-89E4-C9A7CD7CD34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544126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mbulation (</a:t>
            </a:r>
            <a:r>
              <a:rPr lang="en-CA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XAMB</a:t>
            </a:r>
            <a:r>
              <a:rPr lang="en-C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of dams and female offspring was scored by the number of horizontal or x-axis infrared beam interruptions as the animal crosses the cage. All beam (horizontal and vertical) interruptions were scored as total activity (</a:t>
            </a:r>
            <a:r>
              <a:rPr lang="en-CA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XTOT</a:t>
            </a:r>
            <a:r>
              <a:rPr lang="en-C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. Stereotypy (</a:t>
            </a:r>
            <a:r>
              <a:rPr lang="en-CA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ZTOT</a:t>
            </a:r>
            <a:r>
              <a:rPr lang="en-C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, defined as rearing, grooming and scratching was automatically derived by subtracting ambulation from the total activity counts.</a:t>
            </a:r>
          </a:p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B34DEFF-2784-45A7-A5E0-999318094616}" type="slidenum">
              <a:rPr lang="en-CA" smtClean="0"/>
              <a:t>2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654853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B756C7-70E4-4BB4-AE0A-113ECD0EB9B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646F483-A55A-48E6-98E7-6DC7171821F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BEB411-DA67-49AA-B8E3-55CB03FA84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9632A-CDEF-4F90-ACF5-2E24CD5E9F58}" type="datetimeFigureOut">
              <a:rPr lang="en-CA" smtClean="0"/>
              <a:t>2020-12-09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527D49-1646-457E-91C6-CAF207FC3A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936BCC-8C75-48C4-B4EF-05D1A72163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AC73E-EA04-462B-99E6-BD8DEE8F527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693247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3552A0-4D8E-405E-A8BB-8BBE9B3831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E07ADA2-AE79-47B3-93DA-A4A76DBF51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49AC1F-E6FF-46D6-9FC4-3744092979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9632A-CDEF-4F90-ACF5-2E24CD5E9F58}" type="datetimeFigureOut">
              <a:rPr lang="en-CA" smtClean="0"/>
              <a:t>2020-12-09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D66DC8-8E79-4A79-BE35-660CBA806A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5C10C3-AA0E-403A-B040-4D090D6241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AC73E-EA04-462B-99E6-BD8DEE8F527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380957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87B0F96-8023-4107-9B4A-413F942A523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0582398-6874-4379-AC30-94B287BA6B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F375BD-89BC-45C8-A291-BAC49E4833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9632A-CDEF-4F90-ACF5-2E24CD5E9F58}" type="datetimeFigureOut">
              <a:rPr lang="en-CA" smtClean="0"/>
              <a:t>2020-12-09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D5C6E2-CEBE-4476-BE23-69575099A4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EF5E00-CE32-4D19-A77F-F8BD19674A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AC73E-EA04-462B-99E6-BD8DEE8F527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484934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56A3B7-5EA8-4E42-9957-3F1C9542D6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42CCCD-33FE-4FE2-A6E4-9109A79D994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91878C-3EE8-4D4B-9C5A-54DC9F1E2F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9632A-CDEF-4F90-ACF5-2E24CD5E9F58}" type="datetimeFigureOut">
              <a:rPr lang="en-CA" smtClean="0"/>
              <a:t>2020-12-09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E67265-B39F-41C2-A28E-0434C805FC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D860AB-2B4A-485C-84D8-19D2C679A3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AC73E-EA04-462B-99E6-BD8DEE8F527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10627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12CCC7-8123-41AE-91C7-7000A19C6B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BC693A7-3B28-4DE4-8495-441EAB57A8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D6859A-AEBE-4F75-8607-B332319BC6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9632A-CDEF-4F90-ACF5-2E24CD5E9F58}" type="datetimeFigureOut">
              <a:rPr lang="en-CA" smtClean="0"/>
              <a:t>2020-12-09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AF2DC4-08D1-4DC3-8952-8608592095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1ACDF2-1E6A-4BEF-9B57-2AEE814CA1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AC73E-EA04-462B-99E6-BD8DEE8F527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877813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A3B6FD-9B82-4DF9-B1D1-3AB5578211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3B2A234-4C3F-4ED9-AA47-EF81B8B2121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5424110-4AF0-472B-B0B4-954E0FDB17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306BD36-B247-4D8E-893F-DCCD5D6CB9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9632A-CDEF-4F90-ACF5-2E24CD5E9F58}" type="datetimeFigureOut">
              <a:rPr lang="en-CA" smtClean="0"/>
              <a:t>2020-12-09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DE32E34-CE44-4E3A-9C1B-8C8C32E6C0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C3341A-1757-4FC3-A218-A11FC90AE6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AC73E-EA04-462B-99E6-BD8DEE8F527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466616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F2FAEC-3981-4065-8A51-1E3F98DAFE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9CB3FA-7D88-4D7E-A44B-DAE8BA91B1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01FFB4-D277-4628-BD6D-8DEF041C66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43833B1-14A5-4253-BE8C-2349079FBA6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360FF00-ED60-4A34-8C29-9CEA9227957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B21EB6C-8373-439D-B5F5-DC866C9E96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9632A-CDEF-4F90-ACF5-2E24CD5E9F58}" type="datetimeFigureOut">
              <a:rPr lang="en-CA" smtClean="0"/>
              <a:t>2020-12-09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4F5C92D-D0FB-45D8-901D-44E96A83A6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37B9009-041C-4019-9D90-BD167B63A0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AC73E-EA04-462B-99E6-BD8DEE8F527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599526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8FD3E0-D87A-4D28-9BC8-A2EA91D154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9051576-0002-4EB9-AA24-A82879C5FA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9632A-CDEF-4F90-ACF5-2E24CD5E9F58}" type="datetimeFigureOut">
              <a:rPr lang="en-CA" smtClean="0"/>
              <a:t>2020-12-09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FA1DFE1-D8E7-4C87-A1DC-F2591F544C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D3A2A83-2B41-4254-B6E0-87DC7EDB03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AC73E-EA04-462B-99E6-BD8DEE8F527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238783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9152D03-D3B8-4892-A3EB-80823B26A4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9632A-CDEF-4F90-ACF5-2E24CD5E9F58}" type="datetimeFigureOut">
              <a:rPr lang="en-CA" smtClean="0"/>
              <a:t>2020-12-09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2C87D72-BD06-4467-A8BD-A6E90090DF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4A7CED6-0219-4349-A447-3C512EBC9B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AC73E-EA04-462B-99E6-BD8DEE8F527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830845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332549-5263-4DB4-A1F4-76032969F4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3605D1-7BE9-4288-80D6-BFAF848808F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7E86A03-8F66-4AC6-BC48-5454C5E3D9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5BC93C-910E-4EDA-BC37-458540AA14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9632A-CDEF-4F90-ACF5-2E24CD5E9F58}" type="datetimeFigureOut">
              <a:rPr lang="en-CA" smtClean="0"/>
              <a:t>2020-12-09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9635FD5-3143-4C22-A4B2-85CA374361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93EB0EB-CCBB-4038-A185-615DF16E11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AC73E-EA04-462B-99E6-BD8DEE8F527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758299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476CC1-AD6B-45DD-802D-A70BDCD27B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3723A6E-594A-4085-B141-67FEC17EBD6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4C50F3-A713-444E-8612-7B09C0A24C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19D6CD0-2BD1-4C23-8338-AD160B597B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9632A-CDEF-4F90-ACF5-2E24CD5E9F58}" type="datetimeFigureOut">
              <a:rPr lang="en-CA" smtClean="0"/>
              <a:t>2020-12-09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D7EABF-BE92-4AAF-83A4-7F7A3FF1BE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5EE48BA-13AC-4D81-9832-9854903F33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AC73E-EA04-462B-99E6-BD8DEE8F527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665230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D802D00-0128-4118-A5C3-24DFD73910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640877-B99B-4438-8EAD-5EBB05FE04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04B7B5-8E7E-4078-93AE-7AC4BDA4F2D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29632A-CDEF-4F90-ACF5-2E24CD5E9F58}" type="datetimeFigureOut">
              <a:rPr lang="en-CA" smtClean="0"/>
              <a:t>2020-12-09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C60437-DE32-490B-8265-221614C8D8E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BA45E1-7B03-4717-8B4C-0179453BA43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FAC73E-EA04-462B-99E6-BD8DEE8F527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48321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3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6.emf"/><Relationship Id="rId5" Type="http://schemas.openxmlformats.org/officeDocument/2006/relationships/oleObject" Target="../embeddings/oleObject6.bin"/><Relationship Id="rId4" Type="http://schemas.openxmlformats.org/officeDocument/2006/relationships/image" Target="../media/image5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8.emf"/><Relationship Id="rId5" Type="http://schemas.openxmlformats.org/officeDocument/2006/relationships/oleObject" Target="../embeddings/oleObject8.bin"/><Relationship Id="rId4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368F557-DF1F-484C-B8DB-712F95562732}"/>
              </a:ext>
            </a:extLst>
          </p:cNvPr>
          <p:cNvSpPr txBox="1"/>
          <p:nvPr/>
        </p:nvSpPr>
        <p:spPr>
          <a:xfrm>
            <a:off x="191069" y="150125"/>
            <a:ext cx="56777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/>
              <a:t>FigureS1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ECEFD80E-841E-45D8-B816-8148F14DFC0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44429451"/>
              </p:ext>
            </p:extLst>
          </p:nvPr>
        </p:nvGraphicFramePr>
        <p:xfrm>
          <a:off x="3497263" y="1109663"/>
          <a:ext cx="5507037" cy="3595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5" name="Prism 6" r:id="rId3" imgW="4971674" imgH="3174398" progId="Prism6.Document">
                  <p:embed/>
                </p:oleObj>
              </mc:Choice>
              <mc:Fallback>
                <p:oleObj name="Prism 6" r:id="rId3" imgW="4971674" imgH="3174398" progId="Prism6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523AFBE3-8601-4B60-9D7D-5C87EAAFBEB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497263" y="1109663"/>
                        <a:ext cx="5507037" cy="3595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86C6C65B-DCB2-4669-BD13-0F0F9891E106}"/>
              </a:ext>
            </a:extLst>
          </p:cNvPr>
          <p:cNvSpPr txBox="1"/>
          <p:nvPr/>
        </p:nvSpPr>
        <p:spPr>
          <a:xfrm>
            <a:off x="2251969" y="4810119"/>
            <a:ext cx="7688062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CA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Figure S1</a:t>
            </a:r>
            <a:r>
              <a:rPr lang="en-CA" sz="1200" b="1" kern="1200" dirty="0">
                <a:solidFill>
                  <a:srgbClr val="262626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: Weekly weight-gain of dams from weaning to 19-weeks post-weaning (PW).</a:t>
            </a:r>
            <a:r>
              <a:rPr lang="en-CA" sz="1200" b="1" dirty="0">
                <a:solidFill>
                  <a:srgbClr val="262626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CA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nalyzed by Two-way ANOVA. *Significantly different at </a:t>
            </a:r>
            <a:r>
              <a:rPr lang="en-CA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&lt;0.05 </a:t>
            </a:r>
            <a:r>
              <a:rPr lang="en-CA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etween 5X-FA and 5X-MTHF dams only by Tukey post-hoc analysis. </a:t>
            </a:r>
            <a:r>
              <a:rPr lang="en-CA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n =10-12/group. Values are LS Mean ± S.E.M. Diet </a:t>
            </a:r>
            <a:r>
              <a:rPr lang="en-CA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bbreviations: AIN-93G rodent diet with 1X (recommended, 2mg/kg) or 5X folic acid (FA) or equimolar </a:t>
            </a:r>
            <a:r>
              <a:rPr lang="en-CA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[</a:t>
            </a:r>
            <a:r>
              <a:rPr lang="en-CA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6S]‐5‐methyltetrahydrofolic acid calcium salt, </a:t>
            </a:r>
            <a:r>
              <a:rPr lang="en-CA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MTHF) at 1X (2.1 mg/kg) or 5X (10.4mg/kg) levels.  </a:t>
            </a:r>
            <a:endParaRPr lang="en-CA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29151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154E5A07-D5C3-4104-A33C-39C6A75E3929}"/>
              </a:ext>
            </a:extLst>
          </p:cNvPr>
          <p:cNvSpPr txBox="1"/>
          <p:nvPr/>
        </p:nvSpPr>
        <p:spPr>
          <a:xfrm>
            <a:off x="260776" y="112840"/>
            <a:ext cx="2942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/>
              <a:t>Figure S2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1FC64A22-A885-4F78-A5FC-2AA8444F4E23}"/>
              </a:ext>
            </a:extLst>
          </p:cNvPr>
          <p:cNvGrpSpPr/>
          <p:nvPr/>
        </p:nvGrpSpPr>
        <p:grpSpPr>
          <a:xfrm>
            <a:off x="0" y="911137"/>
            <a:ext cx="11790834" cy="3583006"/>
            <a:chOff x="-1199233" y="865568"/>
            <a:chExt cx="11790834" cy="3583006"/>
          </a:xfrm>
        </p:grpSpPr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9030E76B-A115-426F-BB6B-D4C254895682}"/>
                </a:ext>
              </a:extLst>
            </p:cNvPr>
            <p:cNvGrpSpPr/>
            <p:nvPr/>
          </p:nvGrpSpPr>
          <p:grpSpPr>
            <a:xfrm>
              <a:off x="-1199233" y="865568"/>
              <a:ext cx="11790834" cy="3583006"/>
              <a:chOff x="-1452421" y="754699"/>
              <a:chExt cx="11790834" cy="3583006"/>
            </a:xfrm>
          </p:grpSpPr>
          <p:graphicFrame>
            <p:nvGraphicFramePr>
              <p:cNvPr id="3" name="Object 2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590754780"/>
                  </p:ext>
                </p:extLst>
              </p:nvPr>
            </p:nvGraphicFramePr>
            <p:xfrm>
              <a:off x="2219909" y="920292"/>
              <a:ext cx="4122827" cy="331174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077" name="Prism 6" r:id="rId4" imgW="4029559" imgH="3201769" progId="Prism6.Document">
                      <p:embed/>
                    </p:oleObj>
                  </mc:Choice>
                  <mc:Fallback>
                    <p:oleObj name="Prism 6" r:id="rId4" imgW="4029559" imgH="3201769" progId="Prism6.Document">
                      <p:embed/>
                      <p:pic>
                        <p:nvPicPr>
                          <p:cNvPr id="3" name="Object 2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2219909" y="920292"/>
                            <a:ext cx="4122827" cy="331174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4" name="Object 3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078236284"/>
                  </p:ext>
                </p:extLst>
              </p:nvPr>
            </p:nvGraphicFramePr>
            <p:xfrm>
              <a:off x="-1452421" y="920366"/>
              <a:ext cx="4060355" cy="324031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078" name="Prism 6" r:id="rId6" imgW="4056929" imgH="3201769" progId="Prism6.Document">
                      <p:embed/>
                    </p:oleObj>
                  </mc:Choice>
                  <mc:Fallback>
                    <p:oleObj name="Prism 6" r:id="rId6" imgW="4056929" imgH="3201769" progId="Prism6.Document">
                      <p:embed/>
                      <p:pic>
                        <p:nvPicPr>
                          <p:cNvPr id="4" name="Object 3"/>
                          <p:cNvPicPr/>
                          <p:nvPr/>
                        </p:nvPicPr>
                        <p:blipFill>
                          <a:blip r:embed="rId7"/>
                          <a:stretch>
                            <a:fillRect/>
                          </a:stretch>
                        </p:blipFill>
                        <p:spPr>
                          <a:xfrm>
                            <a:off x="-1452421" y="920366"/>
                            <a:ext cx="4060355" cy="3240318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5" name="Object 4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409767792"/>
                  </p:ext>
                </p:extLst>
              </p:nvPr>
            </p:nvGraphicFramePr>
            <p:xfrm>
              <a:off x="5921380" y="814622"/>
              <a:ext cx="4417033" cy="352308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079" name="Prism 6" r:id="rId8" imgW="4056929" imgH="3201769" progId="Prism6.Document">
                      <p:embed/>
                    </p:oleObj>
                  </mc:Choice>
                  <mc:Fallback>
                    <p:oleObj name="Prism 6" r:id="rId8" imgW="4056929" imgH="3201769" progId="Prism6.Document">
                      <p:embed/>
                      <p:pic>
                        <p:nvPicPr>
                          <p:cNvPr id="5" name="Object 4"/>
                          <p:cNvPicPr/>
                          <p:nvPr/>
                        </p:nvPicPr>
                        <p:blipFill>
                          <a:blip r:embed="rId9"/>
                          <a:stretch>
                            <a:fillRect/>
                          </a:stretch>
                        </p:blipFill>
                        <p:spPr>
                          <a:xfrm>
                            <a:off x="5921380" y="814622"/>
                            <a:ext cx="4417033" cy="3523083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0" name="TextBox 9"/>
              <p:cNvSpPr txBox="1"/>
              <p:nvPr/>
            </p:nvSpPr>
            <p:spPr>
              <a:xfrm>
                <a:off x="6867142" y="754699"/>
                <a:ext cx="45908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b="1" dirty="0"/>
                  <a:t>C</a:t>
                </a:r>
              </a:p>
            </p:txBody>
          </p:sp>
        </p:grp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CDDCAD70-EAE2-47B6-8DAB-F18491997279}"/>
                </a:ext>
              </a:extLst>
            </p:cNvPr>
            <p:cNvGrpSpPr/>
            <p:nvPr/>
          </p:nvGrpSpPr>
          <p:grpSpPr>
            <a:xfrm>
              <a:off x="-346081" y="874431"/>
              <a:ext cx="4140735" cy="400891"/>
              <a:chOff x="-346081" y="874431"/>
              <a:chExt cx="4140735" cy="400891"/>
            </a:xfrm>
          </p:grpSpPr>
          <p:sp>
            <p:nvSpPr>
              <p:cNvPr id="8" name="TextBox 7"/>
              <p:cNvSpPr txBox="1"/>
              <p:nvPr/>
            </p:nvSpPr>
            <p:spPr>
              <a:xfrm>
                <a:off x="-346081" y="905990"/>
                <a:ext cx="45908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b="1" dirty="0"/>
                  <a:t>A</a:t>
                </a: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3304810" y="874431"/>
                <a:ext cx="48984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b="1" dirty="0"/>
                  <a:t>B</a:t>
                </a:r>
              </a:p>
            </p:txBody>
          </p:sp>
        </p:grp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BD8DC03C-6984-495D-B1FD-20DA9FAF030A}"/>
              </a:ext>
            </a:extLst>
          </p:cNvPr>
          <p:cNvSpPr txBox="1"/>
          <p:nvPr/>
        </p:nvSpPr>
        <p:spPr>
          <a:xfrm>
            <a:off x="6140258" y="752235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CA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A3C4E1B-4C58-49FA-B6FB-608B238DEDAB}"/>
              </a:ext>
            </a:extLst>
          </p:cNvPr>
          <p:cNvSpPr txBox="1"/>
          <p:nvPr/>
        </p:nvSpPr>
        <p:spPr>
          <a:xfrm>
            <a:off x="714202" y="4677641"/>
            <a:ext cx="10948325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CA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Figure S2</a:t>
            </a:r>
            <a:r>
              <a:rPr lang="en-CA" sz="1200" b="1" kern="1200" dirty="0">
                <a:solidFill>
                  <a:srgbClr val="262626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CA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ocomotor activity at 15-weeks post-weaning in dams fed FA or MTHF pregnancy diets.</a:t>
            </a:r>
            <a:r>
              <a:rPr lang="en-CA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CA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A) </a:t>
            </a:r>
            <a:r>
              <a:rPr lang="en-CA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tereotypy (ZTOT Activity), </a:t>
            </a:r>
            <a:r>
              <a:rPr lang="en-CA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B) </a:t>
            </a:r>
            <a:r>
              <a:rPr lang="en-CA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otal locomotor activity and </a:t>
            </a:r>
            <a:r>
              <a:rPr lang="en-CA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C) </a:t>
            </a:r>
            <a:r>
              <a:rPr lang="en-CA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mbulation (XAMB), respectively during 24hr at 15-weeks PW. </a:t>
            </a:r>
            <a:r>
              <a:rPr lang="en-CA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Values are LS Mean ± S.E.M. Analyzed by Two-way ANOVA, significance at </a:t>
            </a:r>
            <a:r>
              <a:rPr lang="en-CA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&lt;0.05</a:t>
            </a:r>
            <a:r>
              <a:rPr lang="en-CA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CA" sz="1200" kern="12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b</a:t>
            </a:r>
            <a:r>
              <a:rPr lang="en-CA" sz="1200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ignificantly</a:t>
            </a:r>
            <a:r>
              <a:rPr lang="en-CA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different at </a:t>
            </a:r>
            <a:r>
              <a:rPr lang="en-CA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&lt;0.05</a:t>
            </a:r>
            <a:r>
              <a:rPr lang="en-CA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by Tukey’s post-hoc. NS, non-significant. Diet abbreviations: AIN-93G rodent diet with 1X (recommended, 2mg/kg) or 5X folic acid (FA) or equimolar </a:t>
            </a:r>
            <a:r>
              <a:rPr lang="en-CA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[</a:t>
            </a:r>
            <a:r>
              <a:rPr lang="en-CA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6S]‐5‐methyltetrahydrofolic acid calcium salt, </a:t>
            </a:r>
            <a:r>
              <a:rPr lang="en-CA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MTHF) at 1X (2.1 mg/kg) or 5X (10.4mg/kg) levels.  </a:t>
            </a:r>
            <a:endParaRPr lang="en-CA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41486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0699C3A9-F9EC-4B90-AEE9-6D04321DF30B}"/>
              </a:ext>
            </a:extLst>
          </p:cNvPr>
          <p:cNvGrpSpPr/>
          <p:nvPr/>
        </p:nvGrpSpPr>
        <p:grpSpPr>
          <a:xfrm>
            <a:off x="1668463" y="1717049"/>
            <a:ext cx="8712666" cy="3304214"/>
            <a:chOff x="1766118" y="1508352"/>
            <a:chExt cx="8712666" cy="3304214"/>
          </a:xfrm>
        </p:grpSpPr>
        <p:grpSp>
          <p:nvGrpSpPr>
            <p:cNvPr id="4" name="Group 3"/>
            <p:cNvGrpSpPr/>
            <p:nvPr/>
          </p:nvGrpSpPr>
          <p:grpSpPr>
            <a:xfrm>
              <a:off x="1766118" y="1508352"/>
              <a:ext cx="8712666" cy="3304214"/>
              <a:chOff x="1629640" y="406907"/>
              <a:chExt cx="8712666" cy="3304214"/>
            </a:xfrm>
          </p:grpSpPr>
          <p:graphicFrame>
            <p:nvGraphicFramePr>
              <p:cNvPr id="2" name="Object 1"/>
              <p:cNvGraphicFramePr>
                <a:graphicFrameLocks noChangeAspect="1"/>
              </p:cNvGraphicFramePr>
              <p:nvPr/>
            </p:nvGraphicFramePr>
            <p:xfrm>
              <a:off x="6335456" y="406907"/>
              <a:ext cx="4006850" cy="29114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46" name="Prism 6" r:id="rId3" imgW="4006510" imgH="2912206" progId="Prism6.Document">
                      <p:embed/>
                    </p:oleObj>
                  </mc:Choice>
                  <mc:Fallback>
                    <p:oleObj name="Prism 6" r:id="rId3" imgW="4006510" imgH="2912206" progId="Prism6.Document">
                      <p:embed/>
                      <p:pic>
                        <p:nvPicPr>
                          <p:cNvPr id="2" name="Object 1"/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6335456" y="406907"/>
                            <a:ext cx="4006850" cy="29114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5" name="Object 4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112984088"/>
                  </p:ext>
                </p:extLst>
              </p:nvPr>
            </p:nvGraphicFramePr>
            <p:xfrm>
              <a:off x="1629640" y="793296"/>
              <a:ext cx="4478337" cy="29178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47" name="Prism 6" r:id="rId5" imgW="4477567" imgH="2918328" progId="Prism6.Document">
                      <p:embed/>
                    </p:oleObj>
                  </mc:Choice>
                  <mc:Fallback>
                    <p:oleObj name="Prism 6" r:id="rId5" imgW="4477567" imgH="2918328" progId="Prism6.Document">
                      <p:embed/>
                      <p:pic>
                        <p:nvPicPr>
                          <p:cNvPr id="5" name="Object 4"/>
                          <p:cNvPicPr/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1629640" y="793296"/>
                            <a:ext cx="4478337" cy="29178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3" name="TextBox 2"/>
              <p:cNvSpPr txBox="1"/>
              <p:nvPr/>
            </p:nvSpPr>
            <p:spPr>
              <a:xfrm>
                <a:off x="2010859" y="531130"/>
                <a:ext cx="73697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b="1" dirty="0"/>
                  <a:t>A</a:t>
                </a:r>
              </a:p>
            </p:txBody>
          </p:sp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14D33A4-BDD5-4615-B900-C6E6555D84B4}"/>
                </a:ext>
              </a:extLst>
            </p:cNvPr>
            <p:cNvSpPr txBox="1"/>
            <p:nvPr/>
          </p:nvSpPr>
          <p:spPr>
            <a:xfrm>
              <a:off x="6747450" y="1727200"/>
              <a:ext cx="73697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b="1" dirty="0"/>
                <a:t>B</a:t>
              </a:r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2DD7465F-D107-4105-BD9B-4C6CB7198A69}"/>
              </a:ext>
            </a:extLst>
          </p:cNvPr>
          <p:cNvSpPr txBox="1"/>
          <p:nvPr/>
        </p:nvSpPr>
        <p:spPr>
          <a:xfrm>
            <a:off x="191069" y="150125"/>
            <a:ext cx="56777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/>
              <a:t>FigureS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ACE7F51-4225-47C3-9005-350B7073DF50}"/>
              </a:ext>
            </a:extLst>
          </p:cNvPr>
          <p:cNvSpPr txBox="1"/>
          <p:nvPr/>
        </p:nvSpPr>
        <p:spPr>
          <a:xfrm>
            <a:off x="2237173" y="5191859"/>
            <a:ext cx="7688062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CA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Figure S3</a:t>
            </a:r>
            <a:r>
              <a:rPr lang="en-CA" sz="1200" b="1" kern="1200" dirty="0">
                <a:solidFill>
                  <a:srgbClr val="262626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: Insuli</a:t>
            </a:r>
            <a:r>
              <a:rPr lang="en-CA" sz="1200" b="1" dirty="0">
                <a:solidFill>
                  <a:srgbClr val="262626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n Resistance at 1-week PW in dams fed FA or MTHF pregnancy diets. </a:t>
            </a:r>
            <a:r>
              <a:rPr lang="en-CA" sz="1200" b="1" kern="1200" dirty="0">
                <a:solidFill>
                  <a:srgbClr val="262626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A)</a:t>
            </a:r>
            <a:r>
              <a:rPr lang="en-CA" sz="1200" kern="1200" dirty="0">
                <a:solidFill>
                  <a:srgbClr val="262626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Plasma glucose (mmol/l) from 0-120 min and </a:t>
            </a:r>
            <a:r>
              <a:rPr lang="en-CA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B)</a:t>
            </a:r>
            <a:r>
              <a:rPr lang="en-CA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CA" sz="1200" kern="1200" dirty="0">
                <a:solidFill>
                  <a:srgbClr val="262626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</a:t>
            </a:r>
            <a:r>
              <a:rPr lang="en-CA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he rate constant for glucose disappearance (</a:t>
            </a:r>
            <a:r>
              <a:rPr lang="en-CA" sz="1200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kITT</a:t>
            </a:r>
            <a:r>
              <a:rPr lang="en-CA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calculated from 0-60min after </a:t>
            </a:r>
            <a:r>
              <a:rPr lang="en-CA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ntraperitoneal injection of an insulin (0.75 IU/kg BW) </a:t>
            </a:r>
            <a:r>
              <a:rPr lang="en-CA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t 1-week post-weaning (PW). Values are LS Mean ± S.E.M. n =8/group. </a:t>
            </a:r>
            <a:r>
              <a:rPr lang="en-CA" sz="1200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KiTT</a:t>
            </a:r>
            <a:r>
              <a:rPr lang="en-CA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was analyzed by Two-way ANOVA, significance at </a:t>
            </a:r>
            <a:r>
              <a:rPr lang="en-CA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&lt;0.05</a:t>
            </a:r>
            <a:r>
              <a:rPr lang="en-CA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Diet abbreviations: AIN-93G rodent diet with 1X (recommended, 2mg/kg) or 5X folic acid (FA) or equimolar </a:t>
            </a:r>
            <a:r>
              <a:rPr lang="en-CA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[</a:t>
            </a:r>
            <a:r>
              <a:rPr lang="en-CA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6S]‐5‐methyltetrahydrofolic acid calcium salt, </a:t>
            </a:r>
            <a:r>
              <a:rPr lang="en-CA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MTHF) at 1X (2.1 mg/kg) or 5X (10.4mg/kg) levels.  </a:t>
            </a:r>
            <a:endParaRPr lang="en-CA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710982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F50245BC-CB9E-4339-B3AF-A53B3A5C404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328352" y="1700280"/>
          <a:ext cx="4116387" cy="26558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4" name="Prism 6" r:id="rId3" imgW="4116351" imgH="2655776" progId="Prism6.Document">
                  <p:embed/>
                </p:oleObj>
              </mc:Choice>
              <mc:Fallback>
                <p:oleObj name="Prism 6" r:id="rId3" imgW="4116351" imgH="2655776" progId="Prism6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F50245BC-CB9E-4339-B3AF-A53B3A5C404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328352" y="1700280"/>
                        <a:ext cx="4116387" cy="26558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DDB33411-29B0-4869-B01B-EF0F378D5A8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54484500"/>
              </p:ext>
            </p:extLst>
          </p:nvPr>
        </p:nvGraphicFramePr>
        <p:xfrm>
          <a:off x="1004443" y="1700280"/>
          <a:ext cx="6035675" cy="2646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5" name="Prism 6" r:id="rId5" imgW="5403116" imgH="2370894" progId="Prism6.Document">
                  <p:embed/>
                </p:oleObj>
              </mc:Choice>
              <mc:Fallback>
                <p:oleObj name="Prism 6" r:id="rId5" imgW="5403116" imgH="2370894" progId="Prism6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DDB33411-29B0-4869-B01B-EF0F378D5A8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004443" y="1700280"/>
                        <a:ext cx="6035675" cy="26463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F7B97303-3EA9-4A85-B98A-E1EFFB459A66}"/>
              </a:ext>
            </a:extLst>
          </p:cNvPr>
          <p:cNvSpPr txBox="1"/>
          <p:nvPr/>
        </p:nvSpPr>
        <p:spPr>
          <a:xfrm>
            <a:off x="191069" y="150125"/>
            <a:ext cx="2902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800" b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ugure</a:t>
            </a:r>
            <a:r>
              <a:rPr lang="en-CA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S4</a:t>
            </a:r>
            <a:endParaRPr lang="en-CA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EE26609-D8C7-4C9E-B10F-E629DC8038CB}"/>
              </a:ext>
            </a:extLst>
          </p:cNvPr>
          <p:cNvSpPr txBox="1"/>
          <p:nvPr/>
        </p:nvSpPr>
        <p:spPr>
          <a:xfrm>
            <a:off x="1100831" y="163296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DFBC364-C586-45CC-8504-C3B762C5BDA2}"/>
              </a:ext>
            </a:extLst>
          </p:cNvPr>
          <p:cNvSpPr txBox="1"/>
          <p:nvPr/>
        </p:nvSpPr>
        <p:spPr>
          <a:xfrm>
            <a:off x="7425340" y="163295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A56A068-0269-4724-828F-9D6102DAF1F3}"/>
              </a:ext>
            </a:extLst>
          </p:cNvPr>
          <p:cNvSpPr txBox="1"/>
          <p:nvPr/>
        </p:nvSpPr>
        <p:spPr>
          <a:xfrm>
            <a:off x="1400346" y="5204300"/>
            <a:ext cx="939130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Comparison between data derived from </a:t>
            </a:r>
            <a:r>
              <a:rPr lang="en-US" sz="1200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RNAseq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 and </a:t>
            </a:r>
            <a:r>
              <a:rPr lang="en-US" sz="1200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qRT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-PCR in ARC at birth of dams fed 5X-FA or 5X-MTHF pregnancy diets. 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1200" b="0" i="0" dirty="0">
                <a:solidFill>
                  <a:srgbClr val="11111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Log2 fold changes (FC) derived from RT-qPCR and </a:t>
            </a:r>
            <a:r>
              <a:rPr lang="en-US" sz="1200" b="0" i="0" dirty="0" err="1">
                <a:solidFill>
                  <a:srgbClr val="11111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NAseq</a:t>
            </a:r>
            <a:r>
              <a:rPr lang="en-US" sz="1200" b="0" i="0" dirty="0">
                <a:solidFill>
                  <a:srgbClr val="11111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of the 11 validated genes showing reduced or increased expression in the brain of 5X-MTHF dams vs. 5X-FA dams. (B)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demonstrates a positive correlation confirming high reliability of the </a:t>
            </a:r>
            <a:r>
              <a:rPr lang="en-CA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NAseq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 set. Pearson correlation coefficient was used to determine relationship between variables at </a:t>
            </a:r>
            <a:r>
              <a:rPr lang="en-CA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0.05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 </a:t>
            </a:r>
            <a:r>
              <a:rPr lang="en-CA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Gene Abbreviations:</a:t>
            </a:r>
            <a:r>
              <a:rPr lang="en-CA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CA" sz="1200" i="1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ck</a:t>
            </a:r>
            <a:r>
              <a:rPr lang="en-CA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cholecystokinin; </a:t>
            </a:r>
            <a:r>
              <a:rPr lang="en-CA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rh2</a:t>
            </a:r>
            <a:r>
              <a:rPr lang="en-CA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corticotropin-releasing hormone receptor 2; </a:t>
            </a:r>
            <a:r>
              <a:rPr lang="en-CA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Esr1</a:t>
            </a:r>
            <a:r>
              <a:rPr lang="en-CA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estrogen receptor 1; </a:t>
            </a:r>
            <a:r>
              <a:rPr lang="en-CA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Gaba4a</a:t>
            </a:r>
            <a:r>
              <a:rPr lang="en-CA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gamma-aminobutyric acid type A (Gaba) receptor alpha; </a:t>
            </a:r>
            <a:r>
              <a:rPr lang="en-CA" sz="1200" i="1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Gabrd</a:t>
            </a:r>
            <a:r>
              <a:rPr lang="en-CA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CA" sz="1200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gaba</a:t>
            </a:r>
            <a:r>
              <a:rPr lang="en-CA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receptor delta; </a:t>
            </a:r>
            <a:r>
              <a:rPr lang="en-CA" sz="1200" i="1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Gabre</a:t>
            </a:r>
            <a:r>
              <a:rPr lang="en-CA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CA" sz="1200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gaba</a:t>
            </a:r>
            <a:r>
              <a:rPr lang="en-CA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receptor epsilon; </a:t>
            </a:r>
            <a:r>
              <a:rPr lang="en-CA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Grm2</a:t>
            </a:r>
            <a:r>
              <a:rPr lang="en-CA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glutamate receptor 2;  </a:t>
            </a:r>
            <a:r>
              <a:rPr lang="en-CA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Kiss1</a:t>
            </a:r>
            <a:r>
              <a:rPr lang="en-CA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kisspeptin; </a:t>
            </a:r>
            <a:r>
              <a:rPr lang="en-CA" sz="1200" i="1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rhr</a:t>
            </a:r>
            <a:r>
              <a:rPr lang="en-CA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prolactin hormone receptor; </a:t>
            </a:r>
            <a:r>
              <a:rPr lang="en-CA" sz="1200" i="1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rlhr</a:t>
            </a:r>
            <a:r>
              <a:rPr lang="en-CA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prolactin-releasing peptide. </a:t>
            </a:r>
            <a:endParaRPr lang="en-CA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92483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73</TotalTime>
  <Words>631</Words>
  <Application>Microsoft Office PowerPoint</Application>
  <PresentationFormat>Widescreen</PresentationFormat>
  <Paragraphs>17</Paragraphs>
  <Slides>4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4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GraphPad Prism 6 Project</vt:lpstr>
      <vt:lpstr>Prism 6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anuela Pannia</dc:creator>
  <cp:lastModifiedBy>Emanuela Pannia</cp:lastModifiedBy>
  <cp:revision>10</cp:revision>
  <dcterms:created xsi:type="dcterms:W3CDTF">2020-11-16T21:00:28Z</dcterms:created>
  <dcterms:modified xsi:type="dcterms:W3CDTF">2020-12-11T18:03:35Z</dcterms:modified>
</cp:coreProperties>
</file>